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8"/>
  </p:notesMasterIdLst>
  <p:sldIdLst>
    <p:sldId id="267" r:id="rId5"/>
    <p:sldId id="341" r:id="rId6"/>
    <p:sldId id="352" r:id="rId7"/>
  </p:sldIdLst>
  <p:sldSz cx="7772400" cy="10058400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28" autoAdjust="0"/>
    <p:restoredTop sz="94660"/>
  </p:normalViewPr>
  <p:slideViewPr>
    <p:cSldViewPr snapToGrid="0">
      <p:cViewPr>
        <p:scale>
          <a:sx n="156" d="100"/>
          <a:sy n="156" d="100"/>
        </p:scale>
        <p:origin x="320" y="-208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705" y="0"/>
            <a:ext cx="3066733" cy="469780"/>
          </a:xfrm>
          <a:prstGeom prst="rect">
            <a:avLst/>
          </a:prstGeom>
        </p:spPr>
        <p:txBody>
          <a:bodyPr vert="horz" lIns="93936" tIns="46968" rIns="93936" bIns="46968" rtlCol="0"/>
          <a:lstStyle>
            <a:lvl1pPr algn="r">
              <a:defRPr sz="1200"/>
            </a:lvl1pPr>
          </a:lstStyle>
          <a:p>
            <a:fld id="{FB861800-2B7C-4A02-9900-B8CF268123CE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1169988"/>
            <a:ext cx="2441575" cy="31607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936" tIns="46968" rIns="93936" bIns="4696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7708" y="4505980"/>
            <a:ext cx="5661660" cy="3686711"/>
          </a:xfrm>
          <a:prstGeom prst="rect">
            <a:avLst/>
          </a:prstGeom>
        </p:spPr>
        <p:txBody>
          <a:bodyPr vert="horz" lIns="93936" tIns="46968" rIns="93936" bIns="4696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705" y="8893297"/>
            <a:ext cx="3066733" cy="469779"/>
          </a:xfrm>
          <a:prstGeom prst="rect">
            <a:avLst/>
          </a:prstGeom>
        </p:spPr>
        <p:txBody>
          <a:bodyPr vert="horz" lIns="93936" tIns="46968" rIns="93936" bIns="46968" rtlCol="0" anchor="b"/>
          <a:lstStyle>
            <a:lvl1pPr algn="r">
              <a:defRPr sz="1200"/>
            </a:lvl1pPr>
          </a:lstStyle>
          <a:p>
            <a:fld id="{A6DA7404-2E7F-45B0-BF97-24B06F9886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1109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02C4F-336B-430C-ABA0-1DCE86FBDDDC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87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2F8EF1-11E5-49CE-A73A-27339A6B667D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62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889FF-7FCC-46A5-A47C-AE0AB00E4013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205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663F6-2ABA-40B8-82BF-943B1951FD5F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722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486A5-D7B9-427A-8E84-D1E47CD83243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136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6F1D-53F9-449B-8C58-407E8B82DDD0}" type="datetime1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449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0B090E-1BE9-4414-936D-31F643551C57}" type="datetime1">
              <a:rPr lang="en-US" smtClean="0"/>
              <a:t>7/1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510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FF0B88-3F8E-41BD-8019-D559842C8FB0}" type="datetime1">
              <a:rPr lang="en-US" smtClean="0"/>
              <a:t>7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699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F449A-2B14-4529-9178-63553351BBDC}" type="datetime1">
              <a:rPr lang="en-US" smtClean="0"/>
              <a:t>7/1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87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  <a:prstGeom prst="rect">
            <a:avLst/>
          </a:prstGeo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  <a:prstGeom prst="rect">
            <a:avLst/>
          </a:prstGeo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AE32C-EA31-4E77-AF70-07AC20DC3813}" type="datetime1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125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  <a:prstGeom prst="rect">
            <a:avLst/>
          </a:prstGeo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  <a:prstGeom prst="rect">
            <a:avLst/>
          </a:prstGeo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7604F4-DD19-4EB8-B92E-739977CF1B1B}" type="datetime1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334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9615" y="9522883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870C1-F330-4355-9AB3-30557ED28F43}" type="datetime1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13938" y="9322649"/>
            <a:ext cx="1224109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CA3F4182-85E4-422D-A428-2B9D6FDD214E}" type="slidenum">
              <a:rPr lang="en-US" smtClean="0"/>
              <a:pPr/>
              <a:t>‹#›</a:t>
            </a:fld>
            <a:endParaRPr lang="en-US" dirty="0"/>
          </a:p>
        </p:txBody>
      </p:sp>
      <p:grpSp>
        <p:nvGrpSpPr>
          <p:cNvPr id="7" name="Group 6"/>
          <p:cNvGrpSpPr/>
          <p:nvPr userDrawn="1"/>
        </p:nvGrpSpPr>
        <p:grpSpPr>
          <a:xfrm>
            <a:off x="439615" y="226075"/>
            <a:ext cx="7016262" cy="741078"/>
            <a:chOff x="440912" y="201932"/>
            <a:chExt cx="6004133" cy="729740"/>
          </a:xfrm>
        </p:grpSpPr>
        <p:sp>
          <p:nvSpPr>
            <p:cNvPr id="8" name="Rectangle 7"/>
            <p:cNvSpPr/>
            <p:nvPr/>
          </p:nvSpPr>
          <p:spPr>
            <a:xfrm>
              <a:off x="440912" y="201932"/>
              <a:ext cx="6004133" cy="729740"/>
            </a:xfrm>
            <a:prstGeom prst="rect">
              <a:avLst/>
            </a:prstGeom>
            <a:noFill/>
            <a:ln w="25400" cap="flat" cmpd="sng" algn="ctr">
              <a:solidFill>
                <a:srgbClr val="5B9BD5">
                  <a:lumMod val="50000"/>
                </a:srgbClr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148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9" name="Group 8"/>
            <p:cNvGrpSpPr/>
            <p:nvPr/>
          </p:nvGrpSpPr>
          <p:grpSpPr>
            <a:xfrm>
              <a:off x="3966778" y="313017"/>
              <a:ext cx="2478266" cy="615883"/>
              <a:chOff x="4512529" y="343513"/>
              <a:chExt cx="2855516" cy="708688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4512529" y="742685"/>
                <a:ext cx="2855516" cy="309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148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</a:rPr>
                  <a:t>microtrac.com/laboratory-service</a:t>
                </a:r>
              </a:p>
            </p:txBody>
          </p:sp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127071" y="343513"/>
                <a:ext cx="1946090" cy="421375"/>
              </a:xfrm>
              <a:prstGeom prst="rect">
                <a:avLst/>
              </a:prstGeom>
            </p:spPr>
          </p:pic>
        </p:grp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09052" y="221166"/>
              <a:ext cx="1905694" cy="690737"/>
            </a:xfrm>
            <a:prstGeom prst="rect">
              <a:avLst/>
            </a:prstGeom>
          </p:spPr>
        </p:pic>
      </p:grpSp>
      <p:sp>
        <p:nvSpPr>
          <p:cNvPr id="13" name="Footer Placeholder 4"/>
          <p:cNvSpPr txBox="1">
            <a:spLocks/>
          </p:cNvSpPr>
          <p:nvPr userDrawn="1"/>
        </p:nvSpPr>
        <p:spPr>
          <a:xfrm>
            <a:off x="306192" y="9322648"/>
            <a:ext cx="145227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ctr" defTabSz="1003188" rtl="0" eaLnBrk="1" latinLnBrk="0" hangingPunct="1">
              <a:defRPr sz="9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501594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003188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504782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06376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07971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009565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511159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012753" algn="l" defTabSz="1003188" rtl="0" eaLnBrk="1" latinLnBrk="0" hangingPunct="1">
              <a:defRPr sz="197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F-PAL-SYNC Rev B</a:t>
            </a:r>
          </a:p>
        </p:txBody>
      </p:sp>
    </p:spTree>
    <p:extLst>
      <p:ext uri="{BB962C8B-B14F-4D97-AF65-F5344CB8AC3E}">
        <p14:creationId xmlns:p14="http://schemas.microsoft.com/office/powerpoint/2010/main" val="1447184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1</a:t>
            </a:fld>
            <a:endParaRPr lang="en-US"/>
          </a:p>
        </p:txBody>
      </p:sp>
      <p:grpSp>
        <p:nvGrpSpPr>
          <p:cNvPr id="10" name="Group 9"/>
          <p:cNvGrpSpPr/>
          <p:nvPr/>
        </p:nvGrpSpPr>
        <p:grpSpPr>
          <a:xfrm>
            <a:off x="499908" y="1054291"/>
            <a:ext cx="6772582" cy="8272983"/>
            <a:chOff x="499908" y="1054291"/>
            <a:chExt cx="6772582" cy="8272983"/>
          </a:xfrm>
        </p:grpSpPr>
        <p:sp>
          <p:nvSpPr>
            <p:cNvPr id="3" name="TextBox 2"/>
            <p:cNvSpPr txBox="1"/>
            <p:nvPr/>
          </p:nvSpPr>
          <p:spPr>
            <a:xfrm>
              <a:off x="616019" y="1054291"/>
              <a:ext cx="4219750" cy="5201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5000"/>
                </a:lnSpc>
                <a:spcAft>
                  <a:spcPts val="3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Instrument Model: Sync 3R (Dry analysis)</a:t>
              </a:r>
            </a:p>
            <a:p>
              <a:pPr>
                <a:lnSpc>
                  <a:spcPct val="115000"/>
                </a:lnSpc>
                <a:spcAft>
                  <a:spcPts val="3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Sample Identification: Vitamin A – Product A</a:t>
              </a:r>
              <a:endParaRPr lang="en-US" sz="1100" dirty="0">
                <a:latin typeface="Arial" panose="020B0604020202020204" pitchFamily="34" charset="0"/>
                <a:ea typeface="Calibri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16767" y="8819443"/>
              <a:ext cx="4061179" cy="50783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lvl="0" algn="just"/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Figure2.  Images </a:t>
              </a:r>
              <a:r>
                <a:rPr lang="en-US" sz="900" dirty="0">
                  <a:solidFill>
                    <a:prstClr val="black"/>
                  </a:solidFill>
                  <a:cs typeface="Arial" panose="020B0604020202020204" pitchFamily="34" charset="0"/>
                </a:rPr>
                <a:t>- </a:t>
              </a:r>
              <a:r>
                <a:rPr lang="en-US" sz="900" dirty="0">
                  <a:solidFill>
                    <a:prstClr val="black"/>
                  </a:solidFill>
                </a:rPr>
                <a:t>Segment of image file in random order. Particles can be sorted by any of the 30 size/shape parameters in ascending or descending order. Particles can also be classified by size and/or shape and quantified using this feature.</a:t>
              </a:r>
              <a:endParaRPr lang="en-US" sz="900" dirty="0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99908" y="5440470"/>
              <a:ext cx="6772582" cy="50783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Figure1. </a:t>
              </a:r>
            </a:p>
            <a:p>
              <a:pPr algn="just"/>
              <a:r>
                <a:rPr lang="en-US" sz="900" b="1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X-Y Graph</a:t>
              </a:r>
              <a:r>
                <a:rPr lang="en-US" sz="900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 </a:t>
              </a:r>
              <a:r>
                <a:rPr lang="en-US" sz="900" b="1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X-Y Table </a:t>
              </a:r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– </a:t>
              </a:r>
              <a:r>
                <a:rPr lang="en-US" sz="900" dirty="0">
                  <a:solidFill>
                    <a:prstClr val="black"/>
                  </a:solidFill>
                  <a:cs typeface="Arial" panose="020B0604020202020204" pitchFamily="34" charset="0"/>
                </a:rPr>
                <a:t>Channel data are displayed using Area equivalent diameter (Da).  The distribution by image analysis calculation of the area of the particle and then converting it to a sphere having the same area to provide the Da.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56374735-FD39-48FE-85FA-AD5BF7346B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908" y="1605740"/>
            <a:ext cx="6772582" cy="383473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C32B881-64C5-409E-A524-A7B602BC21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5991" y="6061014"/>
            <a:ext cx="4280415" cy="275380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F1247FA-303B-4E02-B637-40179BF7CBA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5359" y="2010024"/>
            <a:ext cx="1229247" cy="582275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40B78A4-C34D-464A-BD59-C56C160ED949}"/>
              </a:ext>
            </a:extLst>
          </p:cNvPr>
          <p:cNvSpPr/>
          <p:nvPr/>
        </p:nvSpPr>
        <p:spPr>
          <a:xfrm>
            <a:off x="1913860" y="1850065"/>
            <a:ext cx="1414131" cy="818707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B9EFBDC-0AD3-E340-8927-D103A276627C}"/>
              </a:ext>
            </a:extLst>
          </p:cNvPr>
          <p:cNvSpPr/>
          <p:nvPr/>
        </p:nvSpPr>
        <p:spPr>
          <a:xfrm>
            <a:off x="616019" y="1297172"/>
            <a:ext cx="3126641" cy="27726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236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2</a:t>
            </a:fld>
            <a:endParaRPr lang="en-US"/>
          </a:p>
        </p:txBody>
      </p:sp>
      <p:grpSp>
        <p:nvGrpSpPr>
          <p:cNvPr id="10" name="Group 9"/>
          <p:cNvGrpSpPr/>
          <p:nvPr/>
        </p:nvGrpSpPr>
        <p:grpSpPr>
          <a:xfrm>
            <a:off x="499908" y="1054291"/>
            <a:ext cx="6772582" cy="8272983"/>
            <a:chOff x="499908" y="1054291"/>
            <a:chExt cx="6772582" cy="8272983"/>
          </a:xfrm>
        </p:grpSpPr>
        <p:sp>
          <p:nvSpPr>
            <p:cNvPr id="3" name="TextBox 2"/>
            <p:cNvSpPr txBox="1"/>
            <p:nvPr/>
          </p:nvSpPr>
          <p:spPr>
            <a:xfrm>
              <a:off x="616019" y="1054291"/>
              <a:ext cx="4219750" cy="5201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15000"/>
                </a:lnSpc>
                <a:spcAft>
                  <a:spcPts val="3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Instrument Model: Sync 3R (Dry analysis)</a:t>
              </a:r>
            </a:p>
            <a:p>
              <a:pPr>
                <a:lnSpc>
                  <a:spcPct val="115000"/>
                </a:lnSpc>
                <a:spcAft>
                  <a:spcPts val="3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/>
                  <a:cs typeface="Arial" panose="020B0604020202020204" pitchFamily="34" charset="0"/>
                </a:rPr>
                <a:t>Sample Identification: Vitamin A – Product B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16767" y="8819443"/>
              <a:ext cx="4061179" cy="50783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pPr lvl="0" algn="just"/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Figure2.  Images </a:t>
              </a:r>
              <a:r>
                <a:rPr lang="en-US" sz="900" dirty="0">
                  <a:solidFill>
                    <a:prstClr val="black"/>
                  </a:solidFill>
                  <a:cs typeface="Arial" panose="020B0604020202020204" pitchFamily="34" charset="0"/>
                </a:rPr>
                <a:t>- </a:t>
              </a:r>
              <a:r>
                <a:rPr lang="en-US" sz="900" dirty="0">
                  <a:solidFill>
                    <a:prstClr val="black"/>
                  </a:solidFill>
                </a:rPr>
                <a:t>Segment of image file in random order. Particles can be sorted by any of the 30 size/shape parameters in ascending or descending order. Particles can also be classified by size and/or shape and quantified using this feature.</a:t>
              </a:r>
              <a:endParaRPr lang="en-US" sz="900" dirty="0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99908" y="5440470"/>
              <a:ext cx="6772582" cy="507831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Figure1. </a:t>
              </a:r>
            </a:p>
            <a:p>
              <a:pPr algn="just"/>
              <a:r>
                <a:rPr lang="en-US" sz="900" b="1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X-Y Graph</a:t>
              </a:r>
              <a:r>
                <a:rPr lang="en-US" sz="900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 </a:t>
              </a:r>
              <a:r>
                <a:rPr lang="en-US" sz="900" b="1" dirty="0">
                  <a:solidFill>
                    <a:prstClr val="black"/>
                  </a:solidFill>
                  <a:latin typeface="Calibri Light" panose="020F0302020204030204"/>
                  <a:cs typeface="Arial" panose="020B0604020202020204" pitchFamily="34" charset="0"/>
                </a:rPr>
                <a:t>X-Y Table </a:t>
              </a:r>
              <a:r>
                <a:rPr lang="en-US" sz="900" b="1" dirty="0">
                  <a:solidFill>
                    <a:prstClr val="black"/>
                  </a:solidFill>
                  <a:cs typeface="Arial" panose="020B0604020202020204" pitchFamily="34" charset="0"/>
                </a:rPr>
                <a:t>– </a:t>
              </a:r>
              <a:r>
                <a:rPr lang="en-US" sz="900" dirty="0">
                  <a:solidFill>
                    <a:prstClr val="black"/>
                  </a:solidFill>
                  <a:cs typeface="Arial" panose="020B0604020202020204" pitchFamily="34" charset="0"/>
                </a:rPr>
                <a:t>Channel data are displayed using Area equivalent diameter (Da).  The distribution by image analysis calculation of the area of the particle and then converting it to a sphere having the same area to provide the Da.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2E476F2A-D68B-4627-9A4D-7952E1768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9908" y="1600170"/>
            <a:ext cx="6772582" cy="383798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5FB8557-A250-43A8-9213-1104B15BF7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1162" y="6093292"/>
            <a:ext cx="4261714" cy="27261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9C31163-DAFF-4435-98C1-7A1E40BBB2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95341" y="2005008"/>
            <a:ext cx="1214960" cy="575507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BEB269E-9470-7342-A5E5-97BD8BCC03F6}"/>
              </a:ext>
            </a:extLst>
          </p:cNvPr>
          <p:cNvSpPr/>
          <p:nvPr/>
        </p:nvSpPr>
        <p:spPr>
          <a:xfrm>
            <a:off x="1913860" y="1850065"/>
            <a:ext cx="1414131" cy="818707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CE479AA-A5DC-744A-A55E-26FC49E41501}"/>
              </a:ext>
            </a:extLst>
          </p:cNvPr>
          <p:cNvSpPr/>
          <p:nvPr/>
        </p:nvSpPr>
        <p:spPr>
          <a:xfrm>
            <a:off x="616019" y="1297172"/>
            <a:ext cx="3126641" cy="277261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481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F4182-85E4-422D-A428-2B9D6FDD214E}" type="slidenum">
              <a:rPr lang="en-US" smtClean="0"/>
              <a:t>3</a:t>
            </a:fld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616019" y="1054291"/>
            <a:ext cx="4219750" cy="270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300"/>
              </a:spcAft>
            </a:pPr>
            <a:r>
              <a:rPr lang="en-US" sz="1100" b="1" dirty="0">
                <a:latin typeface="Arial" panose="020B0604020202020204" pitchFamily="34" charset="0"/>
                <a:ea typeface="Calibri"/>
                <a:cs typeface="Arial" panose="020B0604020202020204" pitchFamily="34" charset="0"/>
              </a:rPr>
              <a:t>Instrument Model: Sync 3R (Dry analysis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EF708CF-49AC-46DC-B55C-353657E82A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1700" y="2143125"/>
            <a:ext cx="6096000" cy="706755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DD2358D-9682-4C41-B97F-464416701CE8}"/>
              </a:ext>
            </a:extLst>
          </p:cNvPr>
          <p:cNvSpPr/>
          <p:nvPr/>
        </p:nvSpPr>
        <p:spPr>
          <a:xfrm>
            <a:off x="1105786" y="5263116"/>
            <a:ext cx="2264735" cy="4890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DDFE208-0612-B346-9408-E7112016CEA7}"/>
              </a:ext>
            </a:extLst>
          </p:cNvPr>
          <p:cNvSpPr/>
          <p:nvPr/>
        </p:nvSpPr>
        <p:spPr>
          <a:xfrm>
            <a:off x="4256568" y="5752214"/>
            <a:ext cx="2264735" cy="489098"/>
          </a:xfrm>
          <a:prstGeom prst="rect">
            <a:avLst/>
          </a:prstGeom>
          <a:noFill/>
          <a:ln w="381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FE5EE07-AD13-064C-A401-1D09F323EDD2}"/>
              </a:ext>
            </a:extLst>
          </p:cNvPr>
          <p:cNvSpPr txBox="1"/>
          <p:nvPr/>
        </p:nvSpPr>
        <p:spPr>
          <a:xfrm>
            <a:off x="219739" y="5184499"/>
            <a:ext cx="8272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 95</a:t>
            </a:r>
          </a:p>
          <a:p>
            <a:r>
              <a:rPr lang="en-US" dirty="0"/>
              <a:t>68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81F580-0DC5-974B-B8B6-D582BBF975E7}"/>
              </a:ext>
            </a:extLst>
          </p:cNvPr>
          <p:cNvSpPr txBox="1"/>
          <p:nvPr/>
        </p:nvSpPr>
        <p:spPr>
          <a:xfrm>
            <a:off x="6921795" y="5648144"/>
            <a:ext cx="8506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 95</a:t>
            </a:r>
          </a:p>
          <a:p>
            <a:r>
              <a:rPr lang="en-US" dirty="0"/>
              <a:t>470</a:t>
            </a:r>
          </a:p>
        </p:txBody>
      </p:sp>
    </p:spTree>
    <p:extLst>
      <p:ext uri="{BB962C8B-B14F-4D97-AF65-F5344CB8AC3E}">
        <p14:creationId xmlns:p14="http://schemas.microsoft.com/office/powerpoint/2010/main" val="756229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Revision xmlns="http://schemas.microsoft.com/sharepoint/v3/fields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844AFFC78811A419E1925359FF4AC5F" ma:contentTypeVersion="4" ma:contentTypeDescription="Create a new document." ma:contentTypeScope="" ma:versionID="c5d82a8d86ca4e7ed86d00aefef3eec1">
  <xsd:schema xmlns:xsd="http://www.w3.org/2001/XMLSchema" xmlns:xs="http://www.w3.org/2001/XMLSchema" xmlns:p="http://schemas.microsoft.com/office/2006/metadata/properties" xmlns:ns2="http://schemas.microsoft.com/sharepoint/v3/fields" targetNamespace="http://schemas.microsoft.com/office/2006/metadata/properties" ma:root="true" ma:fieldsID="764bc8f75099a2b025e43b23204c2690" ns2:_="">
    <xsd:import namespace="http://schemas.microsoft.com/sharepoint/v3/fields"/>
    <xsd:element name="properties">
      <xsd:complexType>
        <xsd:sequence>
          <xsd:element name="documentManagement">
            <xsd:complexType>
              <xsd:all>
                <xsd:element ref="ns2:_Revis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/fields" elementFormDefault="qualified">
    <xsd:import namespace="http://schemas.microsoft.com/office/2006/documentManagement/types"/>
    <xsd:import namespace="http://schemas.microsoft.com/office/infopath/2007/PartnerControls"/>
    <xsd:element name="_Revision" ma:index="10" nillable="true" ma:displayName="Revision" ma:internalName="_Revision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axOccurs="1" ma:index="4" ma:displayName="Title Name"/>
        <xsd:element ref="dc:subject" minOccurs="0" maxOccurs="1" ma:index="11" ma:displayName="Subject"/>
        <xsd:element ref="dc:description" minOccurs="0" maxOccurs="1" ma:index="9" ma:displayName="Comments"/>
        <xsd:element name="keywords" minOccurs="0" maxOccurs="1" type="xsd:string"/>
        <xsd:element ref="dc:language" minOccurs="0" maxOccurs="1"/>
        <xsd:element name="category" minOccurs="0" maxOccurs="1" type="xsd:string" ma:index="8" ma:displayName="Category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3B1C32D-6934-4FF5-A619-5CBB08ADC71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9FCC119-CED1-4317-9944-D07C8656C3F6}">
  <ds:schemaRefs>
    <ds:schemaRef ds:uri="http://www.w3.org/XML/1998/namespace"/>
    <ds:schemaRef ds:uri="http://schemas.microsoft.com/office/2006/metadata/properties"/>
    <ds:schemaRef ds:uri="http://purl.org/dc/elements/1.1/"/>
    <ds:schemaRef ds:uri="http://purl.org/dc/terms/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schemas.microsoft.com/sharepoint/v3/fields"/>
  </ds:schemaRefs>
</ds:datastoreItem>
</file>

<file path=customXml/itemProps3.xml><?xml version="1.0" encoding="utf-8"?>
<ds:datastoreItem xmlns:ds="http://schemas.openxmlformats.org/officeDocument/2006/customXml" ds:itemID="{34C71BFA-5608-4C06-9212-202D1F6AF67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/field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00</TotalTime>
  <Words>240</Words>
  <Application>Microsoft Macintosh PowerPoint</Application>
  <PresentationFormat>Custom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>Particle Characterization Report for Sync DIA-LDA</dc:subject>
  <dc:creator>Phil Plantz</dc:creator>
  <dc:description>Use this template to create customer sample reports for Sync DIA-LDA products</dc:description>
  <cp:lastModifiedBy>Nancy Thiex</cp:lastModifiedBy>
  <cp:revision>344</cp:revision>
  <cp:lastPrinted>2021-05-22T16:29:57Z</cp:lastPrinted>
  <dcterms:created xsi:type="dcterms:W3CDTF">2018-09-11T11:53:33Z</dcterms:created>
  <dcterms:modified xsi:type="dcterms:W3CDTF">2021-07-13T20:15:11Z</dcterms:modified>
  <cp:category>Service Form</cp:category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844AFFC78811A419E1925359FF4AC5F</vt:lpwstr>
  </property>
</Properties>
</file>